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636" r:id="rId3"/>
    <p:sldId id="63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636A6EC-E988-4193-93B2-7E337F1B07F3}" v="3" dt="2024-05-15T05:32:03.6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88136" autoAdjust="0"/>
  </p:normalViewPr>
  <p:slideViewPr>
    <p:cSldViewPr snapToGrid="0">
      <p:cViewPr varScale="1">
        <p:scale>
          <a:sx n="94" d="100"/>
          <a:sy n="94" d="100"/>
        </p:scale>
        <p:origin x="115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ither, Kari Ann" userId="4a4411f3-486b-4b95-bcf6-9ef9461e5246" providerId="ADAL" clId="{A636A6EC-E988-4193-93B2-7E337F1B07F3}"/>
    <pc:docChg chg="custSel addSld delSld modSld">
      <pc:chgData name="Gaither, Kari Ann" userId="4a4411f3-486b-4b95-bcf6-9ef9461e5246" providerId="ADAL" clId="{A636A6EC-E988-4193-93B2-7E337F1B07F3}" dt="2024-05-15T05:33:05.479" v="9" actId="1076"/>
      <pc:docMkLst>
        <pc:docMk/>
      </pc:docMkLst>
      <pc:sldChg chg="del">
        <pc:chgData name="Gaither, Kari Ann" userId="4a4411f3-486b-4b95-bcf6-9ef9461e5246" providerId="ADAL" clId="{A636A6EC-E988-4193-93B2-7E337F1B07F3}" dt="2024-05-15T05:32:12.325" v="4" actId="47"/>
        <pc:sldMkLst>
          <pc:docMk/>
          <pc:sldMk cId="2931780035" sldId="624"/>
        </pc:sldMkLst>
      </pc:sldChg>
      <pc:sldChg chg="del">
        <pc:chgData name="Gaither, Kari Ann" userId="4a4411f3-486b-4b95-bcf6-9ef9461e5246" providerId="ADAL" clId="{A636A6EC-E988-4193-93B2-7E337F1B07F3}" dt="2024-05-15T05:32:16.676" v="5" actId="47"/>
        <pc:sldMkLst>
          <pc:docMk/>
          <pc:sldMk cId="856279445" sldId="635"/>
        </pc:sldMkLst>
      </pc:sldChg>
      <pc:sldChg chg="modSp mod">
        <pc:chgData name="Gaither, Kari Ann" userId="4a4411f3-486b-4b95-bcf6-9ef9461e5246" providerId="ADAL" clId="{A636A6EC-E988-4193-93B2-7E337F1B07F3}" dt="2024-05-15T05:32:57.348" v="7" actId="1076"/>
        <pc:sldMkLst>
          <pc:docMk/>
          <pc:sldMk cId="4172566192" sldId="636"/>
        </pc:sldMkLst>
        <pc:picChg chg="mod">
          <ac:chgData name="Gaither, Kari Ann" userId="4a4411f3-486b-4b95-bcf6-9ef9461e5246" providerId="ADAL" clId="{A636A6EC-E988-4193-93B2-7E337F1B07F3}" dt="2024-05-15T05:32:57.348" v="7" actId="1076"/>
          <ac:picMkLst>
            <pc:docMk/>
            <pc:sldMk cId="4172566192" sldId="636"/>
            <ac:picMk id="5" creationId="{A39D3942-FCDC-A1D3-5CBB-2481B2315FD3}"/>
          </ac:picMkLst>
        </pc:picChg>
      </pc:sldChg>
      <pc:sldChg chg="addSp delSp modSp new mod">
        <pc:chgData name="Gaither, Kari Ann" userId="4a4411f3-486b-4b95-bcf6-9ef9461e5246" providerId="ADAL" clId="{A636A6EC-E988-4193-93B2-7E337F1B07F3}" dt="2024-05-15T05:33:05.479" v="9" actId="1076"/>
        <pc:sldMkLst>
          <pc:docMk/>
          <pc:sldMk cId="113907456" sldId="637"/>
        </pc:sldMkLst>
        <pc:spChg chg="del">
          <ac:chgData name="Gaither, Kari Ann" userId="4a4411f3-486b-4b95-bcf6-9ef9461e5246" providerId="ADAL" clId="{A636A6EC-E988-4193-93B2-7E337F1B07F3}" dt="2024-05-15T05:31:35.666" v="1" actId="478"/>
          <ac:spMkLst>
            <pc:docMk/>
            <pc:sldMk cId="113907456" sldId="637"/>
            <ac:spMk id="2" creationId="{60FC5B6A-9BB2-EA64-F7B4-CE3F638F7E8B}"/>
          </ac:spMkLst>
        </pc:spChg>
        <pc:spChg chg="del">
          <ac:chgData name="Gaither, Kari Ann" userId="4a4411f3-486b-4b95-bcf6-9ef9461e5246" providerId="ADAL" clId="{A636A6EC-E988-4193-93B2-7E337F1B07F3}" dt="2024-05-15T05:31:35.666" v="1" actId="478"/>
          <ac:spMkLst>
            <pc:docMk/>
            <pc:sldMk cId="113907456" sldId="637"/>
            <ac:spMk id="3" creationId="{3C846D31-6F11-FA61-BDF2-F95DA98B4DEC}"/>
          </ac:spMkLst>
        </pc:spChg>
        <pc:picChg chg="add">
          <ac:chgData name="Gaither, Kari Ann" userId="4a4411f3-486b-4b95-bcf6-9ef9461e5246" providerId="ADAL" clId="{A636A6EC-E988-4193-93B2-7E337F1B07F3}" dt="2024-05-15T05:31:38.766" v="2"/>
          <ac:picMkLst>
            <pc:docMk/>
            <pc:sldMk cId="113907456" sldId="637"/>
            <ac:picMk id="4" creationId="{2BB186DD-9714-09C5-CFA2-706A4E3CE6D4}"/>
          </ac:picMkLst>
        </pc:picChg>
        <pc:picChg chg="add mod">
          <ac:chgData name="Gaither, Kari Ann" userId="4a4411f3-486b-4b95-bcf6-9ef9461e5246" providerId="ADAL" clId="{A636A6EC-E988-4193-93B2-7E337F1B07F3}" dt="2024-05-15T05:33:05.479" v="9" actId="1076"/>
          <ac:picMkLst>
            <pc:docMk/>
            <pc:sldMk cId="113907456" sldId="637"/>
            <ac:picMk id="5" creationId="{7F348E50-48FF-E932-9574-0556D6033AB3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9C0FE6-7834-4547-9CD7-3439636524B1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A2776F-F17F-49D1-BD35-B9A559DA5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699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7D644-6354-0886-E5B2-C2FB842236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37E744-5FE0-7B4B-C88B-7BC5860A76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70063-F86A-28E5-50BE-A7C06B45A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34E7D4-00A5-A7A3-F299-00694E9C0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037595-630D-90DF-5DCD-44E72D5DB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664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7859E-7EBB-54A4-4A3E-341533AE95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42E674-D2EC-7EC5-5297-4FA30B2EC4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6FBE87-D668-3D1F-3F9C-108235B8C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6CD9EA-05B8-5AFC-ADA2-2A83392FF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3E0CB9-6E9E-C0B1-8C88-4C03E6D90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441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23D11E-014E-97D9-1DCF-3ABEBD9B00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B95B21-F60A-6AD9-5A1C-C32028E0F0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E01E8D-F419-6AA0-1A58-84DEC970A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F99AC6-4C10-7DD8-52A2-6EADA5565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87AB4E-D161-DE58-3A17-1A03FEF824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139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B63A9-AA31-7AD4-B624-833EB6E3B9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C0DBFB-C929-9C90-E0EC-DACD92FDC2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CBD6B0-556F-D52E-98A2-BDF67C4D6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6BC684-B870-A2A9-45B5-6067F5B02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BBACE1-0F63-32CB-C1FE-95670893E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919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62BB2A-A196-7FA8-FEA0-7EB736D68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48CC6B-C58B-D296-1BAC-BD546B30E0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3EBD6-BB1B-28F3-0ED0-C759A1FEC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96747C-AF0E-7846-BDCD-D518649AB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93D06-A92C-7050-4E0D-7FE840E01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341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5AB27-C8B8-C34B-223E-5649076614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4E6E0-288B-1A3B-997E-9A43D0DF1E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616F09-BC19-F62C-8583-53591C41C9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7CAA6A-6A03-A969-F60B-3D56D4C0F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5D8EC9-A3BA-5542-5F43-BA6466540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76A09D-42FF-5026-A00C-368B286CE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685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51DC6C-4ADE-A199-F8FF-BFD83455ED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535FA2-6861-F270-8FC3-46DFD20CC5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0429C4-81F2-8378-1EC1-D1DB0C7ADA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6785A9-BF0B-577F-602E-FDBE0B4DFA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83ADE6-AFD5-2194-959E-759BF77088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26AC3F-D3E4-0FF4-D593-8B26D8B24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9EF1AF-F7C0-678B-2E1B-AAC3103C7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686296-5871-A207-DBBB-C59CBC0D6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49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D77F48-83B6-1A7D-D5FD-44B1697F64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91C6B3-D99D-DBE2-4E75-2D4C7B664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C85FEA-AA9B-DFC6-A777-B0AEE83E2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3E209D-5044-C9DD-8F44-C258703A9A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445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B550EF-9A71-6FF9-D2F9-A4D6F4FC7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E7E3F3-20D8-3B09-7214-E954664C2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94F801-35FF-98C3-3289-5D86444E4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493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C6FB9-B01B-BA29-6317-9AEBA18A6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B977E2-CB21-3AE6-9C02-4FDC84AAEF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66D4A1-B32C-191D-5AB7-4ECD9C4497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616B58-36FB-5359-FDF7-395B80CBA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091C0C-5B35-F675-C841-F2B5311C9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A9707D-148B-0DD2-81A2-EC62E099E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814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A09469-D5F6-A071-E351-66E855ECC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A3A0CD-DB60-A112-D699-F2AEF03EE4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AA2808-E874-D6D2-0F97-55D99F78E5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3E6595-C14F-80AB-CAFF-5F98817B7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867687-5340-ABF6-631E-69D7B9C76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8E940D-E56B-810D-FE1D-F2FA37EF1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094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BFE34F-DECB-E1BE-27DA-A8FC266175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553D23-6BC6-B15A-9416-4E432BEF1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A4C90F-72FC-A39E-A27D-B0BA47B844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DD613-A405-4C53-90BE-2A231A18FE70}" type="datetimeFigureOut">
              <a:rPr lang="en-US" smtClean="0"/>
              <a:t>5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176501-9D45-B49F-A2C5-03E150250F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44324D-C882-AACC-0F0A-CBAB50F9D7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3C1D7-246B-4FAA-A076-C464D2114E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019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7F2A01-B67A-010E-EF6E-10209ADCA55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Figures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49F2C55-9733-1FB8-DFC8-0C1BBF6A95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14387" y="3621088"/>
            <a:ext cx="10563225" cy="1655762"/>
          </a:xfrm>
        </p:spPr>
        <p:txBody>
          <a:bodyPr>
            <a:normAutofit fontScale="85000" lnSpcReduction="10000"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s of alcohol consumption and tobacco smoking on the composition of the ensemble of drug metabolizing enzymes and transporters in human liver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ri A. Gaither, Dilip Kumar Singh, Guihua Yue, Julia Trudeau, </a:t>
            </a:r>
            <a:r>
              <a:rPr lang="en-US" sz="18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nnapiran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nraj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hilip Lazarus, Dmitri R. Davydov, Bhagwat Prasa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08042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39D3942-FCDC-A1D3-5CBB-2481B2315F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5090"/>
          <a:stretch/>
        </p:blipFill>
        <p:spPr>
          <a:xfrm>
            <a:off x="2524929" y="528320"/>
            <a:ext cx="7142142" cy="6008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25661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F348E50-48FF-E932-9574-0556D6033A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2686" y="416922"/>
            <a:ext cx="9645174" cy="60241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907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</TotalTime>
  <Words>52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ry Figures </vt:lpstr>
      <vt:lpstr>PowerPoint Presentation</vt:lpstr>
      <vt:lpstr>PowerPoint Presentation</vt:lpstr>
    </vt:vector>
  </TitlesOfParts>
  <Company>WSU CPP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 </dc:title>
  <dc:creator>Gaither, Kari Ann</dc:creator>
  <cp:lastModifiedBy>Gaither, Kari Ann</cp:lastModifiedBy>
  <cp:revision>2</cp:revision>
  <dcterms:created xsi:type="dcterms:W3CDTF">2024-05-11T02:29:32Z</dcterms:created>
  <dcterms:modified xsi:type="dcterms:W3CDTF">2024-05-15T05:33:11Z</dcterms:modified>
</cp:coreProperties>
</file>